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85E"/>
    <a:srgbClr val="AA0065"/>
    <a:srgbClr val="004277"/>
    <a:srgbClr val="296DC0"/>
    <a:srgbClr val="0092F7"/>
    <a:srgbClr val="65AA00"/>
    <a:srgbClr val="00437A"/>
    <a:srgbClr val="0066B5"/>
    <a:srgbClr val="00447B"/>
    <a:srgbClr val="00447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1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1/12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1/12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3200" b="1" dirty="0">
                <a:solidFill>
                  <a:schemeClr val="bg1"/>
                </a:solidFill>
              </a:rPr>
              <a:t>Ongoing impacts of childhood-onset glomerular diseases </a:t>
            </a:r>
          </a:p>
          <a:p>
            <a:pPr marL="216000" algn="l"/>
            <a:r>
              <a:rPr lang="en-US" sz="3200" b="1" dirty="0">
                <a:solidFill>
                  <a:schemeClr val="bg1"/>
                </a:solidFill>
              </a:rPr>
              <a:t>during young adulthood</a:t>
            </a:r>
            <a:endParaRPr lang="en-GB" sz="32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A</a:t>
            </a:r>
            <a:r>
              <a:rPr lang="en-US" dirty="0">
                <a:solidFill>
                  <a:schemeClr val="bg1"/>
                </a:solidFill>
              </a:rPr>
              <a:t>nalyze the impact on and distress of patients with childhood-onset glomerular disease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Furuie et al. 20</a:t>
            </a:r>
            <a:r>
              <a:rPr lang="en-US" altLang="ja-JP" sz="2000" b="1" dirty="0">
                <a:solidFill>
                  <a:schemeClr val="bg1"/>
                </a:solidFill>
                <a:latin typeface="+mj-lt"/>
              </a:rPr>
              <a:t>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80138" y="5657671"/>
            <a:ext cx="729104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We conducted a novel study analyzing the ongoing impacts of childhood-onset glomerular disease during the transition from child to adult. This study highlighted the significant impact of medications and exercise restrictions on patient decisions about higher education.</a:t>
            </a:r>
            <a:endParaRPr lang="en-GB" dirty="0">
              <a:solidFill>
                <a:schemeClr val="bg1"/>
              </a:solidFill>
            </a:endParaRPr>
          </a:p>
        </p:txBody>
      </p:sp>
      <p:grpSp>
        <p:nvGrpSpPr>
          <p:cNvPr id="72" name="グループ化 71">
            <a:extLst>
              <a:ext uri="{FF2B5EF4-FFF2-40B4-BE49-F238E27FC236}">
                <a16:creationId xmlns:a16="http://schemas.microsoft.com/office/drawing/2014/main" id="{73F84ABF-930E-578A-3058-D360E9AA51D9}"/>
              </a:ext>
            </a:extLst>
          </p:cNvPr>
          <p:cNvGrpSpPr/>
          <p:nvPr/>
        </p:nvGrpSpPr>
        <p:grpSpPr>
          <a:xfrm>
            <a:off x="118349" y="1634273"/>
            <a:ext cx="11955302" cy="3936951"/>
            <a:chOff x="118349" y="1634273"/>
            <a:chExt cx="11955302" cy="3936951"/>
          </a:xfrm>
        </p:grpSpPr>
        <p:pic>
          <p:nvPicPr>
            <p:cNvPr id="71" name="図 70">
              <a:extLst>
                <a:ext uri="{FF2B5EF4-FFF2-40B4-BE49-F238E27FC236}">
                  <a16:creationId xmlns:a16="http://schemas.microsoft.com/office/drawing/2014/main" id="{3F18E691-7E55-382D-2ED7-2392D8C3802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679817" y="2295224"/>
              <a:ext cx="2536172" cy="3276000"/>
            </a:xfrm>
            <a:prstGeom prst="rect">
              <a:avLst/>
            </a:prstGeom>
          </p:spPr>
        </p:pic>
        <p:sp>
          <p:nvSpPr>
            <p:cNvPr id="26" name="TextBox 25"/>
            <p:cNvSpPr txBox="1"/>
            <p:nvPr/>
          </p:nvSpPr>
          <p:spPr>
            <a:xfrm>
              <a:off x="173448" y="1758951"/>
              <a:ext cx="115059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solidFill>
                    <a:srgbClr val="0065AA"/>
                  </a:solidFill>
                </a:rPr>
                <a:t>DESIGN &amp; OUTCOMES</a:t>
              </a:r>
              <a:r>
                <a:rPr lang="en-GB" dirty="0">
                  <a:solidFill>
                    <a:srgbClr val="0065AA"/>
                  </a:solidFill>
                </a:rPr>
                <a:t>:</a:t>
              </a:r>
            </a:p>
          </p:txBody>
        </p:sp>
        <p:sp>
          <p:nvSpPr>
            <p:cNvPr id="46" name="TextBox 20">
              <a:extLst>
                <a:ext uri="{FF2B5EF4-FFF2-40B4-BE49-F238E27FC236}">
                  <a16:creationId xmlns:a16="http://schemas.microsoft.com/office/drawing/2014/main" id="{86C77C21-7987-C858-CF7E-F89FE7BEB5C5}"/>
                </a:ext>
              </a:extLst>
            </p:cNvPr>
            <p:cNvSpPr txBox="1"/>
            <p:nvPr/>
          </p:nvSpPr>
          <p:spPr>
            <a:xfrm>
              <a:off x="7825007" y="1634273"/>
              <a:ext cx="4248644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dirty="0">
                  <a:solidFill>
                    <a:srgbClr val="00437A"/>
                  </a:solidFill>
                </a:rPr>
                <a:t>Multiple Impacts on Decision-making Process for Higher Education</a:t>
              </a:r>
              <a:endParaRPr lang="en-GB" sz="2000" b="1" dirty="0">
                <a:solidFill>
                  <a:srgbClr val="00437A"/>
                </a:solidFill>
              </a:endParaRPr>
            </a:p>
          </p:txBody>
        </p:sp>
        <p:grpSp>
          <p:nvGrpSpPr>
            <p:cNvPr id="77" name="グループ化 76">
              <a:extLst>
                <a:ext uri="{FF2B5EF4-FFF2-40B4-BE49-F238E27FC236}">
                  <a16:creationId xmlns:a16="http://schemas.microsoft.com/office/drawing/2014/main" id="{98F0696C-0916-19DA-A4D5-3FD9A3E457C4}"/>
                </a:ext>
              </a:extLst>
            </p:cNvPr>
            <p:cNvGrpSpPr/>
            <p:nvPr/>
          </p:nvGrpSpPr>
          <p:grpSpPr>
            <a:xfrm>
              <a:off x="3963642" y="1634273"/>
              <a:ext cx="4320000" cy="3860751"/>
              <a:chOff x="3798146" y="1634273"/>
              <a:chExt cx="4320000" cy="3860751"/>
            </a:xfrm>
          </p:grpSpPr>
          <p:grpSp>
            <p:nvGrpSpPr>
              <p:cNvPr id="49" name="グループ化 48">
                <a:extLst>
                  <a:ext uri="{FF2B5EF4-FFF2-40B4-BE49-F238E27FC236}">
                    <a16:creationId xmlns:a16="http://schemas.microsoft.com/office/drawing/2014/main" id="{3856C6ED-CE8D-0C06-E52D-1084CF2A25CA}"/>
                  </a:ext>
                </a:extLst>
              </p:cNvPr>
              <p:cNvGrpSpPr/>
              <p:nvPr/>
            </p:nvGrpSpPr>
            <p:grpSpPr>
              <a:xfrm>
                <a:off x="3798146" y="1634273"/>
                <a:ext cx="4320000" cy="2665105"/>
                <a:chOff x="3440006" y="1634273"/>
                <a:chExt cx="4320000" cy="2665105"/>
              </a:xfrm>
            </p:grpSpPr>
            <p:pic>
              <p:nvPicPr>
                <p:cNvPr id="47" name="図 46">
                  <a:extLst>
                    <a:ext uri="{FF2B5EF4-FFF2-40B4-BE49-F238E27FC236}">
                      <a16:creationId xmlns:a16="http://schemas.microsoft.com/office/drawing/2014/main" id="{8D227F00-7A82-2DC4-F712-5E287808436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440006" y="2296250"/>
                  <a:ext cx="4320000" cy="2003128"/>
                </a:xfrm>
                <a:prstGeom prst="rect">
                  <a:avLst/>
                </a:prstGeom>
              </p:spPr>
            </p:pic>
            <p:sp>
              <p:nvSpPr>
                <p:cNvPr id="48" name="TextBox 20">
                  <a:extLst>
                    <a:ext uri="{FF2B5EF4-FFF2-40B4-BE49-F238E27FC236}">
                      <a16:creationId xmlns:a16="http://schemas.microsoft.com/office/drawing/2014/main" id="{1B24EAC7-6F6A-AE24-A74E-C285745110F4}"/>
                    </a:ext>
                  </a:extLst>
                </p:cNvPr>
                <p:cNvSpPr txBox="1"/>
                <p:nvPr/>
              </p:nvSpPr>
              <p:spPr>
                <a:xfrm>
                  <a:off x="4159980" y="1634273"/>
                  <a:ext cx="2880052" cy="7078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2000" b="1" dirty="0">
                      <a:solidFill>
                        <a:srgbClr val="00437A"/>
                      </a:solidFill>
                    </a:rPr>
                    <a:t>Distress associated with Glomerular Disease</a:t>
                  </a:r>
                </a:p>
              </p:txBody>
            </p:sp>
          </p:grpSp>
          <p:sp>
            <p:nvSpPr>
              <p:cNvPr id="56" name="TextBox 21">
                <a:extLst>
                  <a:ext uri="{FF2B5EF4-FFF2-40B4-BE49-F238E27FC236}">
                    <a16:creationId xmlns:a16="http://schemas.microsoft.com/office/drawing/2014/main" id="{76F14FC5-A87A-7A28-8CEF-C404C9D24960}"/>
                  </a:ext>
                </a:extLst>
              </p:cNvPr>
              <p:cNvSpPr txBox="1"/>
              <p:nvPr/>
            </p:nvSpPr>
            <p:spPr>
              <a:xfrm>
                <a:off x="4210644" y="4294695"/>
                <a:ext cx="3495004" cy="1200329"/>
              </a:xfrm>
              <a:prstGeom prst="rect">
                <a:avLst/>
              </a:prstGeom>
              <a:noFill/>
              <a:ln>
                <a:solidFill>
                  <a:srgbClr val="00385E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ja-JP" dirty="0">
                    <a:solidFill>
                      <a:srgbClr val="00437A"/>
                    </a:solidFill>
                  </a:rPr>
                  <a:t>Many participants indicated that they suffered not only from </a:t>
                </a:r>
                <a:r>
                  <a:rPr lang="en-US" altLang="ja-JP" b="1" i="1" dirty="0">
                    <a:solidFill>
                      <a:srgbClr val="00437A"/>
                    </a:solidFill>
                  </a:rPr>
                  <a:t>Adverse effects </a:t>
                </a:r>
                <a:r>
                  <a:rPr lang="en-US" altLang="ja-JP" dirty="0">
                    <a:solidFill>
                      <a:srgbClr val="00437A"/>
                    </a:solidFill>
                  </a:rPr>
                  <a:t>due to medication, but also from </a:t>
                </a:r>
                <a:r>
                  <a:rPr lang="en-US" altLang="ja-JP" b="1" i="1" dirty="0">
                    <a:solidFill>
                      <a:srgbClr val="00437A"/>
                    </a:solidFill>
                  </a:rPr>
                  <a:t>Exercise restrictions</a:t>
                </a:r>
                <a:r>
                  <a:rPr lang="en-US" altLang="ja-JP" dirty="0">
                    <a:solidFill>
                      <a:srgbClr val="00437A"/>
                    </a:solidFill>
                  </a:rPr>
                  <a:t>.</a:t>
                </a:r>
                <a:endParaRPr lang="en-GB" dirty="0">
                  <a:solidFill>
                    <a:srgbClr val="00437A"/>
                  </a:solidFill>
                </a:endParaRPr>
              </a:p>
            </p:txBody>
          </p:sp>
        </p:grpSp>
        <p:grpSp>
          <p:nvGrpSpPr>
            <p:cNvPr id="83" name="グループ化 82">
              <a:extLst>
                <a:ext uri="{FF2B5EF4-FFF2-40B4-BE49-F238E27FC236}">
                  <a16:creationId xmlns:a16="http://schemas.microsoft.com/office/drawing/2014/main" id="{9D8B3671-D3B7-BF9D-6709-FB9F5403B3F8}"/>
                </a:ext>
              </a:extLst>
            </p:cNvPr>
            <p:cNvGrpSpPr/>
            <p:nvPr/>
          </p:nvGrpSpPr>
          <p:grpSpPr>
            <a:xfrm>
              <a:off x="118349" y="2350475"/>
              <a:ext cx="3673843" cy="2862752"/>
              <a:chOff x="105253" y="2350475"/>
              <a:chExt cx="3673843" cy="2862752"/>
            </a:xfrm>
          </p:grpSpPr>
          <p:grpSp>
            <p:nvGrpSpPr>
              <p:cNvPr id="81" name="グループ化 80">
                <a:extLst>
                  <a:ext uri="{FF2B5EF4-FFF2-40B4-BE49-F238E27FC236}">
                    <a16:creationId xmlns:a16="http://schemas.microsoft.com/office/drawing/2014/main" id="{0132E797-D115-2A2C-12A3-896F7F07F5E9}"/>
                  </a:ext>
                </a:extLst>
              </p:cNvPr>
              <p:cNvGrpSpPr/>
              <p:nvPr/>
            </p:nvGrpSpPr>
            <p:grpSpPr>
              <a:xfrm>
                <a:off x="105253" y="3332072"/>
                <a:ext cx="1762425" cy="1881155"/>
                <a:chOff x="105253" y="3332072"/>
                <a:chExt cx="1762425" cy="1881155"/>
              </a:xfrm>
            </p:grpSpPr>
            <p:sp>
              <p:nvSpPr>
                <p:cNvPr id="41" name="TextBox 33">
                  <a:extLst>
                    <a:ext uri="{FF2B5EF4-FFF2-40B4-BE49-F238E27FC236}">
                      <a16:creationId xmlns:a16="http://schemas.microsoft.com/office/drawing/2014/main" id="{00CFF05A-BD46-D66E-AA68-96CB4328CB21}"/>
                    </a:ext>
                  </a:extLst>
                </p:cNvPr>
                <p:cNvSpPr txBox="1"/>
                <p:nvPr/>
              </p:nvSpPr>
              <p:spPr>
                <a:xfrm>
                  <a:off x="105253" y="4813117"/>
                  <a:ext cx="1762425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2000" dirty="0">
                      <a:solidFill>
                        <a:srgbClr val="65AA00"/>
                      </a:solidFill>
                    </a:rPr>
                    <a:t>IgAN, </a:t>
                  </a:r>
                  <a:r>
                    <a:rPr lang="en-GB" sz="2000" i="1" dirty="0">
                      <a:solidFill>
                        <a:srgbClr val="65AA00"/>
                      </a:solidFill>
                    </a:rPr>
                    <a:t>n</a:t>
                  </a:r>
                  <a:r>
                    <a:rPr lang="en-GB" sz="2000" dirty="0">
                      <a:solidFill>
                        <a:srgbClr val="65AA00"/>
                      </a:solidFill>
                    </a:rPr>
                    <a:t> = 23</a:t>
                  </a:r>
                </a:p>
              </p:txBody>
            </p:sp>
            <p:sp>
              <p:nvSpPr>
                <p:cNvPr id="43" name="TextBox 32">
                  <a:extLst>
                    <a:ext uri="{FF2B5EF4-FFF2-40B4-BE49-F238E27FC236}">
                      <a16:creationId xmlns:a16="http://schemas.microsoft.com/office/drawing/2014/main" id="{259DB31B-5DD4-E104-2AFB-FAD5638D7745}"/>
                    </a:ext>
                  </a:extLst>
                </p:cNvPr>
                <p:cNvSpPr txBox="1"/>
                <p:nvPr/>
              </p:nvSpPr>
              <p:spPr>
                <a:xfrm>
                  <a:off x="105253" y="3332072"/>
                  <a:ext cx="1762425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2000" dirty="0">
                      <a:solidFill>
                        <a:srgbClr val="296DC0"/>
                      </a:solidFill>
                    </a:rPr>
                    <a:t>INS, </a:t>
                  </a:r>
                  <a:r>
                    <a:rPr lang="en-GB" sz="2000" i="1" dirty="0">
                      <a:solidFill>
                        <a:srgbClr val="296DC0"/>
                      </a:solidFill>
                    </a:rPr>
                    <a:t>n</a:t>
                  </a:r>
                  <a:r>
                    <a:rPr lang="en-GB" sz="2000" dirty="0">
                      <a:solidFill>
                        <a:srgbClr val="296DC0"/>
                      </a:solidFill>
                    </a:rPr>
                    <a:t> = 15</a:t>
                  </a:r>
                </a:p>
              </p:txBody>
            </p:sp>
          </p:grpSp>
          <p:grpSp>
            <p:nvGrpSpPr>
              <p:cNvPr id="78" name="グループ化 77">
                <a:extLst>
                  <a:ext uri="{FF2B5EF4-FFF2-40B4-BE49-F238E27FC236}">
                    <a16:creationId xmlns:a16="http://schemas.microsoft.com/office/drawing/2014/main" id="{CDFF0E6F-9E82-EB5E-99FD-AC1A44CBC032}"/>
                  </a:ext>
                </a:extLst>
              </p:cNvPr>
              <p:cNvGrpSpPr/>
              <p:nvPr/>
            </p:nvGrpSpPr>
            <p:grpSpPr>
              <a:xfrm>
                <a:off x="1327950" y="2813372"/>
                <a:ext cx="577827" cy="1605151"/>
                <a:chOff x="1289850" y="2875425"/>
                <a:chExt cx="577827" cy="1605151"/>
              </a:xfrm>
            </p:grpSpPr>
            <p:cxnSp>
              <p:nvCxnSpPr>
                <p:cNvPr id="64" name="Straight Arrow Connector 13">
                  <a:extLst>
                    <a:ext uri="{FF2B5EF4-FFF2-40B4-BE49-F238E27FC236}">
                      <a16:creationId xmlns:a16="http://schemas.microsoft.com/office/drawing/2014/main" id="{64A2AEE4-6754-C2C1-DC5A-1686000826E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89850" y="2875425"/>
                  <a:ext cx="577827" cy="103460"/>
                </a:xfrm>
                <a:prstGeom prst="straightConnector1">
                  <a:avLst/>
                </a:prstGeom>
                <a:ln w="31750">
                  <a:solidFill>
                    <a:srgbClr val="00437A"/>
                  </a:solidFill>
                  <a:headEnd w="lg" len="med"/>
                  <a:tailEnd type="arrow" w="lg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Straight Arrow Connector 13">
                  <a:extLst>
                    <a:ext uri="{FF2B5EF4-FFF2-40B4-BE49-F238E27FC236}">
                      <a16:creationId xmlns:a16="http://schemas.microsoft.com/office/drawing/2014/main" id="{4D7DB5AF-F13C-1587-C293-E53D0AE5E3E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289850" y="4377116"/>
                  <a:ext cx="577827" cy="103460"/>
                </a:xfrm>
                <a:prstGeom prst="straightConnector1">
                  <a:avLst/>
                </a:prstGeom>
                <a:ln w="31750">
                  <a:solidFill>
                    <a:srgbClr val="AA0065"/>
                  </a:solidFill>
                  <a:headEnd w="lg" len="med"/>
                  <a:tailEnd type="arrow" w="lg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0" name="グループ化 79">
                <a:extLst>
                  <a:ext uri="{FF2B5EF4-FFF2-40B4-BE49-F238E27FC236}">
                    <a16:creationId xmlns:a16="http://schemas.microsoft.com/office/drawing/2014/main" id="{46C5F171-EF6C-5E11-DB8E-113AC9D546FB}"/>
                  </a:ext>
                </a:extLst>
              </p:cNvPr>
              <p:cNvGrpSpPr/>
              <p:nvPr/>
            </p:nvGrpSpPr>
            <p:grpSpPr>
              <a:xfrm>
                <a:off x="729823" y="2350475"/>
                <a:ext cx="513284" cy="2530944"/>
                <a:chOff x="729823" y="2350475"/>
                <a:chExt cx="513284" cy="2530944"/>
              </a:xfrm>
            </p:grpSpPr>
            <p:sp>
              <p:nvSpPr>
                <p:cNvPr id="42" name="Freeform: Shape 46">
                  <a:extLst>
                    <a:ext uri="{FF2B5EF4-FFF2-40B4-BE49-F238E27FC236}">
                      <a16:creationId xmlns:a16="http://schemas.microsoft.com/office/drawing/2014/main" id="{A495DDA3-77B8-B516-F55E-7D1A17501846}"/>
                    </a:ext>
                  </a:extLst>
                </p:cNvPr>
                <p:cNvSpPr/>
                <p:nvPr/>
              </p:nvSpPr>
              <p:spPr>
                <a:xfrm>
                  <a:off x="729823" y="3831521"/>
                  <a:ext cx="513284" cy="1049898"/>
                </a:xfrm>
                <a:custGeom>
                  <a:avLst/>
                  <a:gdLst>
                    <a:gd name="connsiteX0" fmla="*/ 427832 w 855663"/>
                    <a:gd name="connsiteY0" fmla="*/ 350043 h 1750218"/>
                    <a:gd name="connsiteX1" fmla="*/ 556181 w 855663"/>
                    <a:gd name="connsiteY1" fmla="*/ 365601 h 1750218"/>
                    <a:gd name="connsiteX2" fmla="*/ 719535 w 855663"/>
                    <a:gd name="connsiteY2" fmla="*/ 451168 h 1750218"/>
                    <a:gd name="connsiteX3" fmla="*/ 742872 w 855663"/>
                    <a:gd name="connsiteY3" fmla="*/ 493950 h 1750218"/>
                    <a:gd name="connsiteX4" fmla="*/ 851774 w 855663"/>
                    <a:gd name="connsiteY4" fmla="*/ 956786 h 1750218"/>
                    <a:gd name="connsiteX5" fmla="*/ 855663 w 855663"/>
                    <a:gd name="connsiteY5" fmla="*/ 976232 h 1750218"/>
                    <a:gd name="connsiteX6" fmla="*/ 777876 w 855663"/>
                    <a:gd name="connsiteY6" fmla="*/ 1054020 h 1750218"/>
                    <a:gd name="connsiteX7" fmla="*/ 703977 w 855663"/>
                    <a:gd name="connsiteY7" fmla="*/ 995680 h 1750218"/>
                    <a:gd name="connsiteX8" fmla="*/ 622301 w 855663"/>
                    <a:gd name="connsiteY8" fmla="*/ 657304 h 1750218"/>
                    <a:gd name="connsiteX9" fmla="*/ 622301 w 855663"/>
                    <a:gd name="connsiteY9" fmla="*/ 1750218 h 1750218"/>
                    <a:gd name="connsiteX10" fmla="*/ 466726 w 855663"/>
                    <a:gd name="connsiteY10" fmla="*/ 1750218 h 1750218"/>
                    <a:gd name="connsiteX11" fmla="*/ 466726 w 855663"/>
                    <a:gd name="connsiteY11" fmla="*/ 1050131 h 1750218"/>
                    <a:gd name="connsiteX12" fmla="*/ 388938 w 855663"/>
                    <a:gd name="connsiteY12" fmla="*/ 1050131 h 1750218"/>
                    <a:gd name="connsiteX13" fmla="*/ 388938 w 855663"/>
                    <a:gd name="connsiteY13" fmla="*/ 1750218 h 1750218"/>
                    <a:gd name="connsiteX14" fmla="*/ 233363 w 855663"/>
                    <a:gd name="connsiteY14" fmla="*/ 1750218 h 1750218"/>
                    <a:gd name="connsiteX15" fmla="*/ 233363 w 855663"/>
                    <a:gd name="connsiteY15" fmla="*/ 661193 h 1750218"/>
                    <a:gd name="connsiteX16" fmla="*/ 151686 w 855663"/>
                    <a:gd name="connsiteY16" fmla="*/ 999569 h 1750218"/>
                    <a:gd name="connsiteX17" fmla="*/ 77788 w 855663"/>
                    <a:gd name="connsiteY17" fmla="*/ 1057910 h 1750218"/>
                    <a:gd name="connsiteX18" fmla="*/ 0 w 855663"/>
                    <a:gd name="connsiteY18" fmla="*/ 980123 h 1750218"/>
                    <a:gd name="connsiteX19" fmla="*/ 3889 w 855663"/>
                    <a:gd name="connsiteY19" fmla="*/ 960675 h 1750218"/>
                    <a:gd name="connsiteX20" fmla="*/ 112792 w 855663"/>
                    <a:gd name="connsiteY20" fmla="*/ 497840 h 1750218"/>
                    <a:gd name="connsiteX21" fmla="*/ 136129 w 855663"/>
                    <a:gd name="connsiteY21" fmla="*/ 455057 h 1750218"/>
                    <a:gd name="connsiteX22" fmla="*/ 299482 w 855663"/>
                    <a:gd name="connsiteY22" fmla="*/ 369490 h 1750218"/>
                    <a:gd name="connsiteX23" fmla="*/ 427832 w 855663"/>
                    <a:gd name="connsiteY23" fmla="*/ 350043 h 1750218"/>
                    <a:gd name="connsiteX24" fmla="*/ 427831 w 855663"/>
                    <a:gd name="connsiteY24" fmla="*/ 0 h 1750218"/>
                    <a:gd name="connsiteX25" fmla="*/ 583406 w 855663"/>
                    <a:gd name="connsiteY25" fmla="*/ 155575 h 1750218"/>
                    <a:gd name="connsiteX26" fmla="*/ 427831 w 855663"/>
                    <a:gd name="connsiteY26" fmla="*/ 311150 h 1750218"/>
                    <a:gd name="connsiteX27" fmla="*/ 272256 w 855663"/>
                    <a:gd name="connsiteY27" fmla="*/ 155575 h 1750218"/>
                    <a:gd name="connsiteX28" fmla="*/ 427831 w 855663"/>
                    <a:gd name="connsiteY28" fmla="*/ 0 h 17502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</a:cxnLst>
                  <a:rect l="l" t="t" r="r" b="b"/>
                  <a:pathLst>
                    <a:path w="855663" h="1750218">
                      <a:moveTo>
                        <a:pt x="427832" y="350043"/>
                      </a:moveTo>
                      <a:cubicBezTo>
                        <a:pt x="470615" y="350043"/>
                        <a:pt x="513398" y="357821"/>
                        <a:pt x="556181" y="365601"/>
                      </a:cubicBezTo>
                      <a:cubicBezTo>
                        <a:pt x="618412" y="385047"/>
                        <a:pt x="672862" y="412273"/>
                        <a:pt x="719535" y="451168"/>
                      </a:cubicBezTo>
                      <a:cubicBezTo>
                        <a:pt x="731203" y="462835"/>
                        <a:pt x="738983" y="478392"/>
                        <a:pt x="742872" y="493950"/>
                      </a:cubicBezTo>
                      <a:lnTo>
                        <a:pt x="851774" y="956786"/>
                      </a:lnTo>
                      <a:cubicBezTo>
                        <a:pt x="851774" y="960675"/>
                        <a:pt x="855663" y="968454"/>
                        <a:pt x="855663" y="976232"/>
                      </a:cubicBezTo>
                      <a:cubicBezTo>
                        <a:pt x="855663" y="1019016"/>
                        <a:pt x="820659" y="1054020"/>
                        <a:pt x="777876" y="1054020"/>
                      </a:cubicBezTo>
                      <a:cubicBezTo>
                        <a:pt x="742872" y="1054020"/>
                        <a:pt x="711757" y="1026795"/>
                        <a:pt x="703977" y="995680"/>
                      </a:cubicBezTo>
                      <a:lnTo>
                        <a:pt x="622301" y="657304"/>
                      </a:lnTo>
                      <a:lnTo>
                        <a:pt x="622301" y="1750218"/>
                      </a:lnTo>
                      <a:lnTo>
                        <a:pt x="466726" y="1750218"/>
                      </a:lnTo>
                      <a:lnTo>
                        <a:pt x="466726" y="1050131"/>
                      </a:lnTo>
                      <a:lnTo>
                        <a:pt x="388938" y="1050131"/>
                      </a:lnTo>
                      <a:lnTo>
                        <a:pt x="388938" y="1750218"/>
                      </a:lnTo>
                      <a:lnTo>
                        <a:pt x="233363" y="1750218"/>
                      </a:lnTo>
                      <a:lnTo>
                        <a:pt x="233363" y="661193"/>
                      </a:lnTo>
                      <a:lnTo>
                        <a:pt x="151686" y="999569"/>
                      </a:lnTo>
                      <a:cubicBezTo>
                        <a:pt x="143907" y="1030684"/>
                        <a:pt x="112792" y="1057910"/>
                        <a:pt x="77788" y="1057910"/>
                      </a:cubicBezTo>
                      <a:cubicBezTo>
                        <a:pt x="35004" y="1057910"/>
                        <a:pt x="0" y="1022905"/>
                        <a:pt x="0" y="980123"/>
                      </a:cubicBezTo>
                      <a:cubicBezTo>
                        <a:pt x="0" y="972343"/>
                        <a:pt x="3889" y="964564"/>
                        <a:pt x="3889" y="960675"/>
                      </a:cubicBezTo>
                      <a:lnTo>
                        <a:pt x="112792" y="497840"/>
                      </a:lnTo>
                      <a:cubicBezTo>
                        <a:pt x="116682" y="482281"/>
                        <a:pt x="124460" y="466725"/>
                        <a:pt x="136129" y="455057"/>
                      </a:cubicBezTo>
                      <a:cubicBezTo>
                        <a:pt x="182801" y="416162"/>
                        <a:pt x="237252" y="385047"/>
                        <a:pt x="299482" y="369490"/>
                      </a:cubicBezTo>
                      <a:cubicBezTo>
                        <a:pt x="342265" y="357821"/>
                        <a:pt x="385049" y="350043"/>
                        <a:pt x="427832" y="350043"/>
                      </a:cubicBezTo>
                      <a:close/>
                      <a:moveTo>
                        <a:pt x="427831" y="0"/>
                      </a:moveTo>
                      <a:cubicBezTo>
                        <a:pt x="513753" y="0"/>
                        <a:pt x="583406" y="69653"/>
                        <a:pt x="583406" y="155575"/>
                      </a:cubicBezTo>
                      <a:cubicBezTo>
                        <a:pt x="583406" y="241496"/>
                        <a:pt x="513753" y="311150"/>
                        <a:pt x="427831" y="311150"/>
                      </a:cubicBezTo>
                      <a:cubicBezTo>
                        <a:pt x="341910" y="311150"/>
                        <a:pt x="272256" y="241496"/>
                        <a:pt x="272256" y="155575"/>
                      </a:cubicBezTo>
                      <a:cubicBezTo>
                        <a:pt x="272256" y="69653"/>
                        <a:pt x="341910" y="0"/>
                        <a:pt x="427831" y="0"/>
                      </a:cubicBezTo>
                      <a:close/>
                    </a:path>
                  </a:pathLst>
                </a:custGeom>
                <a:solidFill>
                  <a:srgbClr val="65AA00"/>
                </a:solidFill>
                <a:ln w="15081" cap="flat">
                  <a:noFill/>
                  <a:prstDash val="solid"/>
                  <a:miter/>
                </a:ln>
              </p:spPr>
              <p:txBody>
                <a:bodyPr wrap="square" rtlCol="0" anchor="ctr">
                  <a:noAutofit/>
                </a:bodyPr>
                <a:lstStyle/>
                <a:p>
                  <a:endParaRPr lang="en-US" dirty="0"/>
                </a:p>
              </p:txBody>
            </p:sp>
            <p:sp>
              <p:nvSpPr>
                <p:cNvPr id="44" name="Freeform: Shape 46">
                  <a:extLst>
                    <a:ext uri="{FF2B5EF4-FFF2-40B4-BE49-F238E27FC236}">
                      <a16:creationId xmlns:a16="http://schemas.microsoft.com/office/drawing/2014/main" id="{B659FB1F-5E67-4A8C-9CEE-662370084FAD}"/>
                    </a:ext>
                  </a:extLst>
                </p:cNvPr>
                <p:cNvSpPr/>
                <p:nvPr/>
              </p:nvSpPr>
              <p:spPr>
                <a:xfrm>
                  <a:off x="729823" y="2350475"/>
                  <a:ext cx="513284" cy="1049898"/>
                </a:xfrm>
                <a:custGeom>
                  <a:avLst/>
                  <a:gdLst>
                    <a:gd name="connsiteX0" fmla="*/ 427832 w 855663"/>
                    <a:gd name="connsiteY0" fmla="*/ 350043 h 1750218"/>
                    <a:gd name="connsiteX1" fmla="*/ 556181 w 855663"/>
                    <a:gd name="connsiteY1" fmla="*/ 365601 h 1750218"/>
                    <a:gd name="connsiteX2" fmla="*/ 719535 w 855663"/>
                    <a:gd name="connsiteY2" fmla="*/ 451168 h 1750218"/>
                    <a:gd name="connsiteX3" fmla="*/ 742872 w 855663"/>
                    <a:gd name="connsiteY3" fmla="*/ 493950 h 1750218"/>
                    <a:gd name="connsiteX4" fmla="*/ 851774 w 855663"/>
                    <a:gd name="connsiteY4" fmla="*/ 956786 h 1750218"/>
                    <a:gd name="connsiteX5" fmla="*/ 855663 w 855663"/>
                    <a:gd name="connsiteY5" fmla="*/ 976232 h 1750218"/>
                    <a:gd name="connsiteX6" fmla="*/ 777876 w 855663"/>
                    <a:gd name="connsiteY6" fmla="*/ 1054020 h 1750218"/>
                    <a:gd name="connsiteX7" fmla="*/ 703977 w 855663"/>
                    <a:gd name="connsiteY7" fmla="*/ 995680 h 1750218"/>
                    <a:gd name="connsiteX8" fmla="*/ 622301 w 855663"/>
                    <a:gd name="connsiteY8" fmla="*/ 657304 h 1750218"/>
                    <a:gd name="connsiteX9" fmla="*/ 622301 w 855663"/>
                    <a:gd name="connsiteY9" fmla="*/ 1750218 h 1750218"/>
                    <a:gd name="connsiteX10" fmla="*/ 466726 w 855663"/>
                    <a:gd name="connsiteY10" fmla="*/ 1750218 h 1750218"/>
                    <a:gd name="connsiteX11" fmla="*/ 466726 w 855663"/>
                    <a:gd name="connsiteY11" fmla="*/ 1050131 h 1750218"/>
                    <a:gd name="connsiteX12" fmla="*/ 388938 w 855663"/>
                    <a:gd name="connsiteY12" fmla="*/ 1050131 h 1750218"/>
                    <a:gd name="connsiteX13" fmla="*/ 388938 w 855663"/>
                    <a:gd name="connsiteY13" fmla="*/ 1750218 h 1750218"/>
                    <a:gd name="connsiteX14" fmla="*/ 233363 w 855663"/>
                    <a:gd name="connsiteY14" fmla="*/ 1750218 h 1750218"/>
                    <a:gd name="connsiteX15" fmla="*/ 233363 w 855663"/>
                    <a:gd name="connsiteY15" fmla="*/ 661193 h 1750218"/>
                    <a:gd name="connsiteX16" fmla="*/ 151686 w 855663"/>
                    <a:gd name="connsiteY16" fmla="*/ 999569 h 1750218"/>
                    <a:gd name="connsiteX17" fmla="*/ 77788 w 855663"/>
                    <a:gd name="connsiteY17" fmla="*/ 1057910 h 1750218"/>
                    <a:gd name="connsiteX18" fmla="*/ 0 w 855663"/>
                    <a:gd name="connsiteY18" fmla="*/ 980123 h 1750218"/>
                    <a:gd name="connsiteX19" fmla="*/ 3889 w 855663"/>
                    <a:gd name="connsiteY19" fmla="*/ 960675 h 1750218"/>
                    <a:gd name="connsiteX20" fmla="*/ 112792 w 855663"/>
                    <a:gd name="connsiteY20" fmla="*/ 497840 h 1750218"/>
                    <a:gd name="connsiteX21" fmla="*/ 136129 w 855663"/>
                    <a:gd name="connsiteY21" fmla="*/ 455057 h 1750218"/>
                    <a:gd name="connsiteX22" fmla="*/ 299482 w 855663"/>
                    <a:gd name="connsiteY22" fmla="*/ 369490 h 1750218"/>
                    <a:gd name="connsiteX23" fmla="*/ 427832 w 855663"/>
                    <a:gd name="connsiteY23" fmla="*/ 350043 h 1750218"/>
                    <a:gd name="connsiteX24" fmla="*/ 427831 w 855663"/>
                    <a:gd name="connsiteY24" fmla="*/ 0 h 1750218"/>
                    <a:gd name="connsiteX25" fmla="*/ 583406 w 855663"/>
                    <a:gd name="connsiteY25" fmla="*/ 155575 h 1750218"/>
                    <a:gd name="connsiteX26" fmla="*/ 427831 w 855663"/>
                    <a:gd name="connsiteY26" fmla="*/ 311150 h 1750218"/>
                    <a:gd name="connsiteX27" fmla="*/ 272256 w 855663"/>
                    <a:gd name="connsiteY27" fmla="*/ 155575 h 1750218"/>
                    <a:gd name="connsiteX28" fmla="*/ 427831 w 855663"/>
                    <a:gd name="connsiteY28" fmla="*/ 0 h 17502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</a:cxnLst>
                  <a:rect l="l" t="t" r="r" b="b"/>
                  <a:pathLst>
                    <a:path w="855663" h="1750218">
                      <a:moveTo>
                        <a:pt x="427832" y="350043"/>
                      </a:moveTo>
                      <a:cubicBezTo>
                        <a:pt x="470615" y="350043"/>
                        <a:pt x="513398" y="357821"/>
                        <a:pt x="556181" y="365601"/>
                      </a:cubicBezTo>
                      <a:cubicBezTo>
                        <a:pt x="618412" y="385047"/>
                        <a:pt x="672862" y="412273"/>
                        <a:pt x="719535" y="451168"/>
                      </a:cubicBezTo>
                      <a:cubicBezTo>
                        <a:pt x="731203" y="462835"/>
                        <a:pt x="738983" y="478392"/>
                        <a:pt x="742872" y="493950"/>
                      </a:cubicBezTo>
                      <a:lnTo>
                        <a:pt x="851774" y="956786"/>
                      </a:lnTo>
                      <a:cubicBezTo>
                        <a:pt x="851774" y="960675"/>
                        <a:pt x="855663" y="968454"/>
                        <a:pt x="855663" y="976232"/>
                      </a:cubicBezTo>
                      <a:cubicBezTo>
                        <a:pt x="855663" y="1019016"/>
                        <a:pt x="820659" y="1054020"/>
                        <a:pt x="777876" y="1054020"/>
                      </a:cubicBezTo>
                      <a:cubicBezTo>
                        <a:pt x="742872" y="1054020"/>
                        <a:pt x="711757" y="1026795"/>
                        <a:pt x="703977" y="995680"/>
                      </a:cubicBezTo>
                      <a:lnTo>
                        <a:pt x="622301" y="657304"/>
                      </a:lnTo>
                      <a:lnTo>
                        <a:pt x="622301" y="1750218"/>
                      </a:lnTo>
                      <a:lnTo>
                        <a:pt x="466726" y="1750218"/>
                      </a:lnTo>
                      <a:lnTo>
                        <a:pt x="466726" y="1050131"/>
                      </a:lnTo>
                      <a:lnTo>
                        <a:pt x="388938" y="1050131"/>
                      </a:lnTo>
                      <a:lnTo>
                        <a:pt x="388938" y="1750218"/>
                      </a:lnTo>
                      <a:lnTo>
                        <a:pt x="233363" y="1750218"/>
                      </a:lnTo>
                      <a:lnTo>
                        <a:pt x="233363" y="661193"/>
                      </a:lnTo>
                      <a:lnTo>
                        <a:pt x="151686" y="999569"/>
                      </a:lnTo>
                      <a:cubicBezTo>
                        <a:pt x="143907" y="1030684"/>
                        <a:pt x="112792" y="1057910"/>
                        <a:pt x="77788" y="1057910"/>
                      </a:cubicBezTo>
                      <a:cubicBezTo>
                        <a:pt x="35004" y="1057910"/>
                        <a:pt x="0" y="1022905"/>
                        <a:pt x="0" y="980123"/>
                      </a:cubicBezTo>
                      <a:cubicBezTo>
                        <a:pt x="0" y="972343"/>
                        <a:pt x="3889" y="964564"/>
                        <a:pt x="3889" y="960675"/>
                      </a:cubicBezTo>
                      <a:lnTo>
                        <a:pt x="112792" y="497840"/>
                      </a:lnTo>
                      <a:cubicBezTo>
                        <a:pt x="116682" y="482281"/>
                        <a:pt x="124460" y="466725"/>
                        <a:pt x="136129" y="455057"/>
                      </a:cubicBezTo>
                      <a:cubicBezTo>
                        <a:pt x="182801" y="416162"/>
                        <a:pt x="237252" y="385047"/>
                        <a:pt x="299482" y="369490"/>
                      </a:cubicBezTo>
                      <a:cubicBezTo>
                        <a:pt x="342265" y="357821"/>
                        <a:pt x="385049" y="350043"/>
                        <a:pt x="427832" y="350043"/>
                      </a:cubicBezTo>
                      <a:close/>
                      <a:moveTo>
                        <a:pt x="427831" y="0"/>
                      </a:moveTo>
                      <a:cubicBezTo>
                        <a:pt x="513753" y="0"/>
                        <a:pt x="583406" y="69653"/>
                        <a:pt x="583406" y="155575"/>
                      </a:cubicBezTo>
                      <a:cubicBezTo>
                        <a:pt x="583406" y="241496"/>
                        <a:pt x="513753" y="311150"/>
                        <a:pt x="427831" y="311150"/>
                      </a:cubicBezTo>
                      <a:cubicBezTo>
                        <a:pt x="341910" y="311150"/>
                        <a:pt x="272256" y="241496"/>
                        <a:pt x="272256" y="155575"/>
                      </a:cubicBezTo>
                      <a:cubicBezTo>
                        <a:pt x="272256" y="69653"/>
                        <a:pt x="341910" y="0"/>
                        <a:pt x="427831" y="0"/>
                      </a:cubicBezTo>
                      <a:close/>
                    </a:path>
                  </a:pathLst>
                </a:custGeom>
                <a:solidFill>
                  <a:srgbClr val="296DC0"/>
                </a:solidFill>
                <a:ln w="15081" cap="flat">
                  <a:noFill/>
                  <a:prstDash val="solid"/>
                  <a:miter/>
                </a:ln>
              </p:spPr>
              <p:txBody>
                <a:bodyPr wrap="square" rtlCol="0" anchor="ctr">
                  <a:noAutofit/>
                </a:bodyPr>
                <a:lstStyle/>
                <a:p>
                  <a:endParaRPr lang="en-US" dirty="0"/>
                </a:p>
              </p:txBody>
            </p:sp>
          </p:grpSp>
          <p:grpSp>
            <p:nvGrpSpPr>
              <p:cNvPr id="63" name="グループ化 62">
                <a:extLst>
                  <a:ext uri="{FF2B5EF4-FFF2-40B4-BE49-F238E27FC236}">
                    <a16:creationId xmlns:a16="http://schemas.microsoft.com/office/drawing/2014/main" id="{ED1672DF-C2D7-B931-8B7B-7C3CE2AF2C37}"/>
                  </a:ext>
                </a:extLst>
              </p:cNvPr>
              <p:cNvGrpSpPr/>
              <p:nvPr/>
            </p:nvGrpSpPr>
            <p:grpSpPr>
              <a:xfrm>
                <a:off x="2043783" y="2639804"/>
                <a:ext cx="1735313" cy="1952286"/>
                <a:chOff x="2005683" y="2860831"/>
                <a:chExt cx="1735313" cy="1952286"/>
              </a:xfrm>
            </p:grpSpPr>
            <p:sp>
              <p:nvSpPr>
                <p:cNvPr id="6" name="Rectangle 3">
                  <a:extLst>
                    <a:ext uri="{FF2B5EF4-FFF2-40B4-BE49-F238E27FC236}">
                      <a16:creationId xmlns:a16="http://schemas.microsoft.com/office/drawing/2014/main" id="{8219C101-978C-A083-09D5-ED026C9E68D5}"/>
                    </a:ext>
                  </a:extLst>
                </p:cNvPr>
                <p:cNvSpPr/>
                <p:nvPr/>
              </p:nvSpPr>
              <p:spPr>
                <a:xfrm>
                  <a:off x="2005683" y="2860831"/>
                  <a:ext cx="1735313" cy="622841"/>
                </a:xfrm>
                <a:prstGeom prst="rect">
                  <a:avLst/>
                </a:prstGeom>
                <a:solidFill>
                  <a:srgbClr val="00385E"/>
                </a:solidFill>
                <a:ln w="41275">
                  <a:solidFill>
                    <a:srgbClr val="00385E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GB" b="1" dirty="0"/>
                    <a:t>Questionnaire</a:t>
                  </a:r>
                </a:p>
                <a:p>
                  <a:pPr algn="ctr"/>
                  <a:r>
                    <a:rPr lang="en-GB" b="1" dirty="0"/>
                    <a:t>Survey</a:t>
                  </a:r>
                </a:p>
              </p:txBody>
            </p:sp>
            <p:sp>
              <p:nvSpPr>
                <p:cNvPr id="57" name="Rectangle 55">
                  <a:extLst>
                    <a:ext uri="{FF2B5EF4-FFF2-40B4-BE49-F238E27FC236}">
                      <a16:creationId xmlns:a16="http://schemas.microsoft.com/office/drawing/2014/main" id="{18074DF0-FE64-6ECF-5CF6-ACAE8E1BBBA7}"/>
                    </a:ext>
                  </a:extLst>
                </p:cNvPr>
                <p:cNvSpPr/>
                <p:nvPr/>
              </p:nvSpPr>
              <p:spPr>
                <a:xfrm>
                  <a:off x="2009147" y="4198894"/>
                  <a:ext cx="1728385" cy="614223"/>
                </a:xfrm>
                <a:prstGeom prst="rect">
                  <a:avLst/>
                </a:prstGeom>
                <a:solidFill>
                  <a:srgbClr val="AA0065"/>
                </a:solidFill>
                <a:ln w="41275">
                  <a:noFill/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GB" b="1" dirty="0"/>
                    <a:t>Clinical</a:t>
                  </a:r>
                </a:p>
                <a:p>
                  <a:pPr algn="ctr"/>
                  <a:r>
                    <a:rPr lang="en-GB" b="1" dirty="0"/>
                    <a:t>Information</a:t>
                  </a:r>
                </a:p>
              </p:txBody>
            </p:sp>
            <p:sp>
              <p:nvSpPr>
                <p:cNvPr id="62" name="十字形 61">
                  <a:extLst>
                    <a:ext uri="{FF2B5EF4-FFF2-40B4-BE49-F238E27FC236}">
                      <a16:creationId xmlns:a16="http://schemas.microsoft.com/office/drawing/2014/main" id="{01B696FF-097F-03D6-8DF1-49B40CE8EA4A}"/>
                    </a:ext>
                  </a:extLst>
                </p:cNvPr>
                <p:cNvSpPr/>
                <p:nvPr/>
              </p:nvSpPr>
              <p:spPr>
                <a:xfrm>
                  <a:off x="2657339" y="3625283"/>
                  <a:ext cx="432000" cy="432000"/>
                </a:xfrm>
                <a:prstGeom prst="plus">
                  <a:avLst>
                    <a:gd name="adj" fmla="val 36379"/>
                  </a:avLst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79" name="グループ化 78">
                <a:extLst>
                  <a:ext uri="{FF2B5EF4-FFF2-40B4-BE49-F238E27FC236}">
                    <a16:creationId xmlns:a16="http://schemas.microsoft.com/office/drawing/2014/main" id="{29827329-F9A1-C4AE-886D-AA58B8FE2A82}"/>
                  </a:ext>
                </a:extLst>
              </p:cNvPr>
              <p:cNvGrpSpPr/>
              <p:nvPr/>
            </p:nvGrpSpPr>
            <p:grpSpPr>
              <a:xfrm>
                <a:off x="1327950" y="2920066"/>
                <a:ext cx="602219" cy="1391762"/>
                <a:chOff x="1289850" y="2965823"/>
                <a:chExt cx="602219" cy="1391762"/>
              </a:xfrm>
            </p:grpSpPr>
            <p:cxnSp>
              <p:nvCxnSpPr>
                <p:cNvPr id="66" name="Straight Arrow Connector 13">
                  <a:extLst>
                    <a:ext uri="{FF2B5EF4-FFF2-40B4-BE49-F238E27FC236}">
                      <a16:creationId xmlns:a16="http://schemas.microsoft.com/office/drawing/2014/main" id="{A6DADBBB-C2B8-E48A-F229-A065FB05FC03}"/>
                    </a:ext>
                  </a:extLst>
                </p:cNvPr>
                <p:cNvCxnSpPr>
                  <a:cxnSpLocks noChangeAspect="1"/>
                </p:cNvCxnSpPr>
                <p:nvPr/>
              </p:nvCxnSpPr>
              <p:spPr>
                <a:xfrm flipV="1">
                  <a:off x="1289850" y="3175373"/>
                  <a:ext cx="602219" cy="1182212"/>
                </a:xfrm>
                <a:prstGeom prst="straightConnector1">
                  <a:avLst/>
                </a:prstGeom>
                <a:ln w="31750">
                  <a:solidFill>
                    <a:srgbClr val="00437A"/>
                  </a:solidFill>
                  <a:headEnd w="lg" len="med"/>
                  <a:tailEnd type="arrow" w="lg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Straight Arrow Connector 13">
                  <a:extLst>
                    <a:ext uri="{FF2B5EF4-FFF2-40B4-BE49-F238E27FC236}">
                      <a16:creationId xmlns:a16="http://schemas.microsoft.com/office/drawing/2014/main" id="{571DD2BC-5127-26E1-F2A3-88E3668117E4}"/>
                    </a:ext>
                  </a:extLst>
                </p:cNvPr>
                <p:cNvCxnSpPr>
                  <a:cxnSpLocks noChangeAspect="1"/>
                </p:cNvCxnSpPr>
                <p:nvPr/>
              </p:nvCxnSpPr>
              <p:spPr>
                <a:xfrm>
                  <a:off x="1289850" y="2965823"/>
                  <a:ext cx="602219" cy="1182212"/>
                </a:xfrm>
                <a:prstGeom prst="straightConnector1">
                  <a:avLst/>
                </a:prstGeom>
                <a:ln w="31750">
                  <a:solidFill>
                    <a:srgbClr val="AA0065"/>
                  </a:solidFill>
                  <a:headEnd w="lg" len="med"/>
                  <a:tailEnd type="arrow" w="lg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98</TotalTime>
  <Words>123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1</cp:revision>
  <dcterms:created xsi:type="dcterms:W3CDTF">2019-06-13T12:30:18Z</dcterms:created>
  <dcterms:modified xsi:type="dcterms:W3CDTF">2023-12-01T22:33:42Z</dcterms:modified>
</cp:coreProperties>
</file>